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6"/>
  </p:notesMasterIdLst>
  <p:sldIdLst>
    <p:sldId id="375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3" d="100"/>
          <a:sy n="63" d="100"/>
        </p:scale>
        <p:origin x="696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ynthia Campbell" userId="5a7b6c23-9dc0-4c57-8403-b7d26b1977f9" providerId="ADAL" clId="{D11D2783-1888-43FD-8729-CDDAADBA1B87}"/>
    <pc:docChg chg="custSel modSld">
      <pc:chgData name="Cynthia Campbell" userId="5a7b6c23-9dc0-4c57-8403-b7d26b1977f9" providerId="ADAL" clId="{D11D2783-1888-43FD-8729-CDDAADBA1B87}" dt="2024-06-30T00:54:31.038" v="1" actId="478"/>
      <pc:docMkLst>
        <pc:docMk/>
      </pc:docMkLst>
      <pc:sldChg chg="delSp modSp mod">
        <pc:chgData name="Cynthia Campbell" userId="5a7b6c23-9dc0-4c57-8403-b7d26b1977f9" providerId="ADAL" clId="{D11D2783-1888-43FD-8729-CDDAADBA1B87}" dt="2024-06-30T00:54:31.038" v="1" actId="478"/>
        <pc:sldMkLst>
          <pc:docMk/>
          <pc:sldMk cId="723953540" sldId="375"/>
        </pc:sldMkLst>
        <pc:spChg chg="del mod">
          <ac:chgData name="Cynthia Campbell" userId="5a7b6c23-9dc0-4c57-8403-b7d26b1977f9" providerId="ADAL" clId="{D11D2783-1888-43FD-8729-CDDAADBA1B87}" dt="2024-06-30T00:54:31.038" v="1" actId="478"/>
          <ac:spMkLst>
            <pc:docMk/>
            <pc:sldMk cId="723953540" sldId="375"/>
            <ac:spMk id="6" creationId="{00000000-0000-0000-0000-000000000000}"/>
          </ac:spMkLst>
        </pc:spChg>
      </pc:sldChg>
    </pc:docChg>
  </pc:docChgLst>
  <pc:docChgLst>
    <pc:chgData name="Cynthia Campbell" userId="5a7b6c23-9dc0-4c57-8403-b7d26b1977f9" providerId="ADAL" clId="{2D663F45-C98D-475C-BF7B-9747016EE5D2}"/>
    <pc:docChg chg="undo custSel modSld">
      <pc:chgData name="Cynthia Campbell" userId="5a7b6c23-9dc0-4c57-8403-b7d26b1977f9" providerId="ADAL" clId="{2D663F45-C98D-475C-BF7B-9747016EE5D2}" dt="2024-05-10T03:33:14.916" v="1068" actId="20577"/>
      <pc:docMkLst>
        <pc:docMk/>
      </pc:docMkLst>
      <pc:sldChg chg="addSp delSp modSp mod">
        <pc:chgData name="Cynthia Campbell" userId="5a7b6c23-9dc0-4c57-8403-b7d26b1977f9" providerId="ADAL" clId="{2D663F45-C98D-475C-BF7B-9747016EE5D2}" dt="2024-05-10T03:33:14.916" v="1068" actId="20577"/>
        <pc:sldMkLst>
          <pc:docMk/>
          <pc:sldMk cId="723953540" sldId="375"/>
        </pc:sldMkLst>
        <pc:spChg chg="mod">
          <ac:chgData name="Cynthia Campbell" userId="5a7b6c23-9dc0-4c57-8403-b7d26b1977f9" providerId="ADAL" clId="{2D663F45-C98D-475C-BF7B-9747016EE5D2}" dt="2024-05-10T03:23:23.337" v="706" actId="20577"/>
          <ac:spMkLst>
            <pc:docMk/>
            <pc:sldMk cId="723953540" sldId="375"/>
            <ac:spMk id="6" creationId="{00000000-0000-0000-0000-000000000000}"/>
          </ac:spMkLst>
        </pc:spChg>
        <pc:spChg chg="del mod">
          <ac:chgData name="Cynthia Campbell" userId="5a7b6c23-9dc0-4c57-8403-b7d26b1977f9" providerId="ADAL" clId="{2D663F45-C98D-475C-BF7B-9747016EE5D2}" dt="2024-05-10T03:28:07.133" v="891" actId="478"/>
          <ac:spMkLst>
            <pc:docMk/>
            <pc:sldMk cId="723953540" sldId="375"/>
            <ac:spMk id="42" creationId="{F162138E-449B-402B-98FC-F95169216659}"/>
          </ac:spMkLst>
        </pc:spChg>
        <pc:spChg chg="mod">
          <ac:chgData name="Cynthia Campbell" userId="5a7b6c23-9dc0-4c57-8403-b7d26b1977f9" providerId="ADAL" clId="{2D663F45-C98D-475C-BF7B-9747016EE5D2}" dt="2024-05-10T03:30:34.148" v="942" actId="1035"/>
          <ac:spMkLst>
            <pc:docMk/>
            <pc:sldMk cId="723953540" sldId="375"/>
            <ac:spMk id="57" creationId="{0C72D4AF-5CA0-439C-8922-5511420B5EFB}"/>
          </ac:spMkLst>
        </pc:spChg>
        <pc:spChg chg="mod">
          <ac:chgData name="Cynthia Campbell" userId="5a7b6c23-9dc0-4c57-8403-b7d26b1977f9" providerId="ADAL" clId="{2D663F45-C98D-475C-BF7B-9747016EE5D2}" dt="2024-05-10T03:30:43.966" v="961" actId="1035"/>
          <ac:spMkLst>
            <pc:docMk/>
            <pc:sldMk cId="723953540" sldId="375"/>
            <ac:spMk id="58" creationId="{9BE5A0F7-C5F1-8F4A-4EF4-5ECAFE911399}"/>
          </ac:spMkLst>
        </pc:spChg>
        <pc:spChg chg="mod">
          <ac:chgData name="Cynthia Campbell" userId="5a7b6c23-9dc0-4c57-8403-b7d26b1977f9" providerId="ADAL" clId="{2D663F45-C98D-475C-BF7B-9747016EE5D2}" dt="2024-05-10T03:33:14.916" v="1068" actId="20577"/>
          <ac:spMkLst>
            <pc:docMk/>
            <pc:sldMk cId="723953540" sldId="375"/>
            <ac:spMk id="61" creationId="{4D9CF05B-2929-0361-0C7F-A6E01B3570D5}"/>
          </ac:spMkLst>
        </pc:spChg>
        <pc:spChg chg="del">
          <ac:chgData name="Cynthia Campbell" userId="5a7b6c23-9dc0-4c57-8403-b7d26b1977f9" providerId="ADAL" clId="{2D663F45-C98D-475C-BF7B-9747016EE5D2}" dt="2024-05-09T23:52:01.214" v="321" actId="478"/>
          <ac:spMkLst>
            <pc:docMk/>
            <pc:sldMk cId="723953540" sldId="375"/>
            <ac:spMk id="65" creationId="{5776508C-ACDE-B021-8C1C-DF995C75624A}"/>
          </ac:spMkLst>
        </pc:spChg>
        <pc:spChg chg="mod topLvl">
          <ac:chgData name="Cynthia Campbell" userId="5a7b6c23-9dc0-4c57-8403-b7d26b1977f9" providerId="ADAL" clId="{2D663F45-C98D-475C-BF7B-9747016EE5D2}" dt="2024-05-10T03:28:57.420" v="910" actId="14100"/>
          <ac:spMkLst>
            <pc:docMk/>
            <pc:sldMk cId="723953540" sldId="375"/>
            <ac:spMk id="68" creationId="{52CAD566-375A-E30E-13D0-936F3287EE12}"/>
          </ac:spMkLst>
        </pc:spChg>
        <pc:spChg chg="del mod topLvl">
          <ac:chgData name="Cynthia Campbell" userId="5a7b6c23-9dc0-4c57-8403-b7d26b1977f9" providerId="ADAL" clId="{2D663F45-C98D-475C-BF7B-9747016EE5D2}" dt="2024-05-10T00:20:25.535" v="677" actId="478"/>
          <ac:spMkLst>
            <pc:docMk/>
            <pc:sldMk cId="723953540" sldId="375"/>
            <ac:spMk id="69" creationId="{B7F531F4-5673-93DF-B4D6-5EFC213B9F01}"/>
          </ac:spMkLst>
        </pc:spChg>
        <pc:grpChg chg="del mod">
          <ac:chgData name="Cynthia Campbell" userId="5a7b6c23-9dc0-4c57-8403-b7d26b1977f9" providerId="ADAL" clId="{2D663F45-C98D-475C-BF7B-9747016EE5D2}" dt="2024-05-09T23:52:33.492" v="325" actId="165"/>
          <ac:grpSpMkLst>
            <pc:docMk/>
            <pc:sldMk cId="723953540" sldId="375"/>
            <ac:grpSpMk id="62" creationId="{1FD7F166-4757-526E-D2C8-E4A4DEED71F5}"/>
          </ac:grpSpMkLst>
        </pc:grpChg>
        <pc:cxnChg chg="add mod">
          <ac:chgData name="Cynthia Campbell" userId="5a7b6c23-9dc0-4c57-8403-b7d26b1977f9" providerId="ADAL" clId="{2D663F45-C98D-475C-BF7B-9747016EE5D2}" dt="2024-05-10T03:31:02.323" v="989" actId="14100"/>
          <ac:cxnSpMkLst>
            <pc:docMk/>
            <pc:sldMk cId="723953540" sldId="375"/>
            <ac:cxnSpMk id="22" creationId="{44541C6F-C955-42D6-8F65-1987E5618D6C}"/>
          </ac:cxnSpMkLst>
        </pc:cxnChg>
        <pc:cxnChg chg="add del mod">
          <ac:chgData name="Cynthia Campbell" userId="5a7b6c23-9dc0-4c57-8403-b7d26b1977f9" providerId="ADAL" clId="{2D663F45-C98D-475C-BF7B-9747016EE5D2}" dt="2024-05-10T03:32:58.857" v="1067" actId="478"/>
          <ac:cxnSpMkLst>
            <pc:docMk/>
            <pc:sldMk cId="723953540" sldId="375"/>
            <ac:cxnSpMk id="27" creationId="{B1A08A5E-7E34-4EB5-B60E-62F5410B7F0E}"/>
          </ac:cxnSpMkLst>
        </pc:cxnChg>
        <pc:cxnChg chg="del">
          <ac:chgData name="Cynthia Campbell" userId="5a7b6c23-9dc0-4c57-8403-b7d26b1977f9" providerId="ADAL" clId="{2D663F45-C98D-475C-BF7B-9747016EE5D2}" dt="2024-05-10T03:23:49.217" v="712" actId="478"/>
          <ac:cxnSpMkLst>
            <pc:docMk/>
            <pc:sldMk cId="723953540" sldId="375"/>
            <ac:cxnSpMk id="33" creationId="{F3F632DC-F476-D449-19A0-EAD693788CE9}"/>
          </ac:cxnSpMkLst>
        </pc:cxnChg>
        <pc:cxnChg chg="del mod topLvl">
          <ac:chgData name="Cynthia Campbell" userId="5a7b6c23-9dc0-4c57-8403-b7d26b1977f9" providerId="ADAL" clId="{2D663F45-C98D-475C-BF7B-9747016EE5D2}" dt="2024-05-10T00:21:07.502" v="684" actId="478"/>
          <ac:cxnSpMkLst>
            <pc:docMk/>
            <pc:sldMk cId="723953540" sldId="375"/>
            <ac:cxnSpMk id="63" creationId="{6ABA4A17-9CA1-F013-C05F-89F654F0464A}"/>
          </ac:cxnSpMkLst>
        </pc:cxnChg>
        <pc:cxnChg chg="del">
          <ac:chgData name="Cynthia Campbell" userId="5a7b6c23-9dc0-4c57-8403-b7d26b1977f9" providerId="ADAL" clId="{2D663F45-C98D-475C-BF7B-9747016EE5D2}" dt="2024-05-09T23:52:18.780" v="324" actId="478"/>
          <ac:cxnSpMkLst>
            <pc:docMk/>
            <pc:sldMk cId="723953540" sldId="375"/>
            <ac:cxnSpMk id="64" creationId="{417CB21A-5446-746A-148F-4C115AF131BC}"/>
          </ac:cxnSpMkLst>
        </pc:cxnChg>
        <pc:cxnChg chg="mod topLvl">
          <ac:chgData name="Cynthia Campbell" userId="5a7b6c23-9dc0-4c57-8403-b7d26b1977f9" providerId="ADAL" clId="{2D663F45-C98D-475C-BF7B-9747016EE5D2}" dt="2024-05-10T03:30:22.499" v="922" actId="14100"/>
          <ac:cxnSpMkLst>
            <pc:docMk/>
            <pc:sldMk cId="723953540" sldId="375"/>
            <ac:cxnSpMk id="72" creationId="{2E58B87E-06C9-2622-8210-673FCDBE066B}"/>
          </ac:cxnSpMkLst>
        </pc:cxnChg>
        <pc:cxnChg chg="mod topLvl">
          <ac:chgData name="Cynthia Campbell" userId="5a7b6c23-9dc0-4c57-8403-b7d26b1977f9" providerId="ADAL" clId="{2D663F45-C98D-475C-BF7B-9747016EE5D2}" dt="2024-05-10T03:32:56.393" v="1066" actId="14100"/>
          <ac:cxnSpMkLst>
            <pc:docMk/>
            <pc:sldMk cId="723953540" sldId="375"/>
            <ac:cxnSpMk id="76" creationId="{2956CA56-283E-FEDA-971B-D33028C703C9}"/>
          </ac:cxnSpMkLst>
        </pc:cxnChg>
        <pc:cxnChg chg="mod topLvl">
          <ac:chgData name="Cynthia Campbell" userId="5a7b6c23-9dc0-4c57-8403-b7d26b1977f9" providerId="ADAL" clId="{2D663F45-C98D-475C-BF7B-9747016EE5D2}" dt="2024-05-10T03:30:27.406" v="923" actId="14100"/>
          <ac:cxnSpMkLst>
            <pc:docMk/>
            <pc:sldMk cId="723953540" sldId="375"/>
            <ac:cxnSpMk id="78" creationId="{320E7B3F-8A35-732A-BA61-890607A41E6F}"/>
          </ac:cxnSpMkLst>
        </pc:cxnChg>
      </pc:sldChg>
    </pc:docChg>
  </pc:docChgLst>
  <pc:docChgLst>
    <pc:chgData name="Teresa Y Lin" userId="S::teresa.y.lin@kp.org::d81f8dd1-4708-41a2-842e-1f1a826e29d2" providerId="AD" clId="Web-{86298519-E8E0-48FE-B1C7-5FA6DF50FF84}"/>
    <pc:docChg chg="modSld">
      <pc:chgData name="Teresa Y Lin" userId="S::teresa.y.lin@kp.org::d81f8dd1-4708-41a2-842e-1f1a826e29d2" providerId="AD" clId="Web-{86298519-E8E0-48FE-B1C7-5FA6DF50FF84}" dt="2024-06-13T18:19:04.757" v="0" actId="20577"/>
      <pc:docMkLst>
        <pc:docMk/>
      </pc:docMkLst>
      <pc:sldChg chg="modSp">
        <pc:chgData name="Teresa Y Lin" userId="S::teresa.y.lin@kp.org::d81f8dd1-4708-41a2-842e-1f1a826e29d2" providerId="AD" clId="Web-{86298519-E8E0-48FE-B1C7-5FA6DF50FF84}" dt="2024-06-13T18:19:04.757" v="0" actId="20577"/>
        <pc:sldMkLst>
          <pc:docMk/>
          <pc:sldMk cId="723953540" sldId="375"/>
        </pc:sldMkLst>
        <pc:spChg chg="mod">
          <ac:chgData name="Teresa Y Lin" userId="S::teresa.y.lin@kp.org::d81f8dd1-4708-41a2-842e-1f1a826e29d2" providerId="AD" clId="Web-{86298519-E8E0-48FE-B1C7-5FA6DF50FF84}" dt="2024-06-13T18:19:04.757" v="0" actId="20577"/>
          <ac:spMkLst>
            <pc:docMk/>
            <pc:sldMk cId="723953540" sldId="375"/>
            <ac:spMk id="61" creationId="{4D9CF05B-2929-0361-0C7F-A6E01B3570D5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F3928C2-4A6F-44DA-AC89-E1138F315572}" type="datetimeFigureOut">
              <a:rPr lang="en-US" smtClean="0"/>
              <a:t>6/29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A3B633B-5AC1-4EBA-AAB4-B3EB61163A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28453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vl="1">
              <a:buFont typeface="Wingdings" panose="05000000000000000000" pitchFamily="2" charset="2"/>
              <a:buChar char="Ø"/>
            </a:pPr>
            <a:r>
              <a:rPr lang="en-US" sz="2000">
                <a:effectLst/>
                <a:ea typeface="Calibri" panose="020F0502020204030204" pitchFamily="34" charset="0"/>
              </a:rPr>
              <a:t>Kaiser Permanente Northern California (KPNC) members had one or more visit to psychiatry department from 5/2020 to 12/2021.</a:t>
            </a:r>
            <a:r>
              <a:rPr lang="en-US" sz="2000">
                <a:ea typeface="Calibri" panose="020F0502020204030204" pitchFamily="34" charset="0"/>
              </a:rPr>
              <a:t> </a:t>
            </a:r>
          </a:p>
          <a:p>
            <a:pPr marL="0" lvl="1" indent="0">
              <a:buNone/>
            </a:pPr>
            <a:endParaRPr lang="en-US" sz="2000">
              <a:effectLst/>
              <a:ea typeface="Calibri" panose="020F0502020204030204" pitchFamily="34" charset="0"/>
            </a:endParaRPr>
          </a:p>
          <a:p>
            <a:pPr lvl="1">
              <a:buFont typeface="Wingdings" panose="05000000000000000000" pitchFamily="2" charset="2"/>
              <a:buChar char="Ø"/>
            </a:pPr>
            <a:r>
              <a:rPr lang="en-US" sz="2000" b="1"/>
              <a:t>Inclusion criteria</a:t>
            </a:r>
          </a:p>
          <a:p>
            <a:pPr lvl="3">
              <a:buFont typeface="Arial" panose="020B0604020202020204" pitchFamily="34" charset="0"/>
              <a:buChar char="•"/>
            </a:pPr>
            <a:r>
              <a:rPr lang="en-US" sz="2000">
                <a:ea typeface="Calibri" panose="020F0502020204030204" pitchFamily="34" charset="0"/>
              </a:rPr>
              <a:t>Member referred to Calm or </a:t>
            </a:r>
            <a:r>
              <a:rPr lang="en-US" sz="2000" err="1">
                <a:ea typeface="Calibri" panose="020F0502020204030204" pitchFamily="34" charset="0"/>
              </a:rPr>
              <a:t>myStrength</a:t>
            </a:r>
            <a:r>
              <a:rPr lang="en-US" sz="2000">
                <a:ea typeface="Calibri" panose="020F0502020204030204" pitchFamily="34" charset="0"/>
              </a:rPr>
              <a:t> during 5/2020 to 12/2021 from psychiatry department</a:t>
            </a:r>
            <a:endParaRPr lang="en-US" sz="2000">
              <a:ea typeface="Calibri" panose="020F0502020204030204" pitchFamily="34" charset="0"/>
              <a:cs typeface="Arial"/>
            </a:endParaRPr>
          </a:p>
          <a:p>
            <a:pPr lvl="3">
              <a:buFont typeface="Arial" panose="020B0604020202020204" pitchFamily="34" charset="0"/>
              <a:buChar char="•"/>
            </a:pPr>
            <a:r>
              <a:rPr lang="en-US" sz="2000"/>
              <a:t>KP membership 1 year prior to index date/procedure</a:t>
            </a:r>
          </a:p>
          <a:p>
            <a:pPr lvl="3">
              <a:buFont typeface="Arial" panose="020B0604020202020204" pitchFamily="34" charset="0"/>
              <a:buChar char="•"/>
            </a:pPr>
            <a:r>
              <a:rPr lang="en-US" sz="2000"/>
              <a:t>Adult age &gt;= 18</a:t>
            </a:r>
          </a:p>
          <a:p>
            <a:pPr lvl="3">
              <a:buFont typeface="Arial" panose="020B0604020202020204" pitchFamily="34" charset="0"/>
              <a:buChar char="•"/>
            </a:pPr>
            <a:r>
              <a:rPr lang="en-US" sz="2000"/>
              <a:t>Select 1</a:t>
            </a:r>
            <a:r>
              <a:rPr lang="en-US" sz="2000" baseline="30000"/>
              <a:t>st</a:t>
            </a:r>
            <a:r>
              <a:rPr lang="en-US" sz="2000"/>
              <a:t> visit when there are multiple psychiatry visits</a:t>
            </a:r>
          </a:p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89942DC-AD1B-DD4D-8BD4-0CB1FC5393D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55692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0A445F-C979-4657-80B6-1EE71CC7C36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4D85137-47CC-47FE-8EC9-9EDC89DE5E3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8C158B-B360-4189-A94E-CC55D9058D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9DF50-F92D-4D13-91A3-C7AB7449A668}" type="datetimeFigureOut">
              <a:rPr lang="en-US" smtClean="0"/>
              <a:t>6/2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F0E309-7871-4D25-A85C-09EA8C5A81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248F3A-9A2C-4A0C-ACE1-0480E31516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8CE31E-7448-4A97-9AD1-07EB3AE79A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53314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060667-4AA6-42FA-A25F-5EB1BEB127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4524354-FCFC-4144-A069-5A4631D867C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7C5624-A81A-4166-A5A1-6FF5690FA1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9DF50-F92D-4D13-91A3-C7AB7449A668}" type="datetimeFigureOut">
              <a:rPr lang="en-US" smtClean="0"/>
              <a:t>6/2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CA69C7-9C54-408A-928A-A2B44ABDA4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ABA0A9-8E32-4976-8881-C12EF084CF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8CE31E-7448-4A97-9AD1-07EB3AE79A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26852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0CC4E88-9BDD-429C-A176-11293DEF788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708F5F9-A1AD-445E-8B17-64327D0ECBA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3EB280-D2D0-4FBD-B2A7-0A87F2E0F8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9DF50-F92D-4D13-91A3-C7AB7449A668}" type="datetimeFigureOut">
              <a:rPr lang="en-US" smtClean="0"/>
              <a:t>6/2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9BBB76-A53B-4CED-A3DC-979C8BFD36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BDE0CD-9D3C-4308-A1E3-C592992E12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8CE31E-7448-4A97-9AD1-07EB3AE79A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87358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26DA14-8625-4938-9284-047B1FDB81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6880B2F-59CF-493B-B8EC-4006905AFDF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50181F-37D4-45DB-8707-1D8CA864D1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9DF50-F92D-4D13-91A3-C7AB7449A668}" type="datetimeFigureOut">
              <a:rPr lang="en-US" smtClean="0"/>
              <a:t>6/2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78B7D1-4452-45BD-AB2D-5ECDBA415C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DF8D61-5769-4E73-AB7A-6506531F59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8CE31E-7448-4A97-9AD1-07EB3AE79A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63406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437787-DCA0-491E-A9A2-F7E0B29B1A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976DE37-2DD2-4671-9106-EE55615DF7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E183CA-B34F-41C6-8AE2-25999844A6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9DF50-F92D-4D13-91A3-C7AB7449A668}" type="datetimeFigureOut">
              <a:rPr lang="en-US" smtClean="0"/>
              <a:t>6/2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035095-1EC6-4612-9B4A-CE8B56299D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C4D6F0-D3B1-4265-BAF5-D52F49236B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8CE31E-7448-4A97-9AD1-07EB3AE79A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22042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0E69C2-646E-4E5F-9B3A-F388846989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1965E8B-1C51-4FC6-A244-CCC56399AA2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87BF0E3-EC4F-405B-936A-1F199A75A1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C9A0193-3591-4206-859F-848C0BEB0E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9DF50-F92D-4D13-91A3-C7AB7449A668}" type="datetimeFigureOut">
              <a:rPr lang="en-US" smtClean="0"/>
              <a:t>6/2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BBB0522-D932-469C-B5FB-0595D565D1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A2AA1DF-BFFA-4C84-86EF-B438890C25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8CE31E-7448-4A97-9AD1-07EB3AE79A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21119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2A8121-11F8-4FAD-ABDA-56900E5D35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593E0B1-A225-4EE5-B44F-1B65A9AE1A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1811B5E-3AFD-4AD4-92A9-FB9C2EAD693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0580E6B-52D2-4649-98D7-7DB942EB3F2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8EBAA56-3B14-4A3A-B5DD-4023CDAC9B7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578989D-8425-4A05-8EA6-3CF65281E7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9DF50-F92D-4D13-91A3-C7AB7449A668}" type="datetimeFigureOut">
              <a:rPr lang="en-US" smtClean="0"/>
              <a:t>6/29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DBBA4A7-2640-4866-831A-FB18E534E0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4267F08-642A-4D7C-B497-B09ACBD623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8CE31E-7448-4A97-9AD1-07EB3AE79A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42938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F3E062-19BA-4566-B780-AB1E70C63B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6BC378C-7B21-4D81-89C2-F053C472D2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9DF50-F92D-4D13-91A3-C7AB7449A668}" type="datetimeFigureOut">
              <a:rPr lang="en-US" smtClean="0"/>
              <a:t>6/29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BA6720A-D909-4A20-98DC-66F2B06124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3D15B9C-73B9-4DB3-B479-E32DE3B7AC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8CE31E-7448-4A97-9AD1-07EB3AE79A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52450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E955A85-A1AD-440B-A713-D7FFB7A755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9DF50-F92D-4D13-91A3-C7AB7449A668}" type="datetimeFigureOut">
              <a:rPr lang="en-US" smtClean="0"/>
              <a:t>6/29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097204C-FE43-4F15-BC46-F6712D4763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E7AF6BD-EB16-418B-999F-518ECAB8E2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8CE31E-7448-4A97-9AD1-07EB3AE79A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50305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D6FC1C-5430-480C-B49A-0E76E94F67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7B70746-3147-4238-9D2E-D06E5328A76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94803A2-A7E8-4F3C-967C-A66BC741754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9B2BB90-35AE-45D9-9C28-DA2DAD7FC1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9DF50-F92D-4D13-91A3-C7AB7449A668}" type="datetimeFigureOut">
              <a:rPr lang="en-US" smtClean="0"/>
              <a:t>6/2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6839350-FB06-4B3F-AE08-1CB20B0D40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A4BCB91-7F66-4203-98B9-804B248CC4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8CE31E-7448-4A97-9AD1-07EB3AE79A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71725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C3479E-8670-492D-85C2-9068E19A18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5916B08-C847-46C6-AEB6-07A5DF6CA8D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4E6FA4A-0D39-4078-91D6-6F62065130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3107CAD-23AD-447D-9AB3-7AA882043C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9DF50-F92D-4D13-91A3-C7AB7449A668}" type="datetimeFigureOut">
              <a:rPr lang="en-US" smtClean="0"/>
              <a:t>6/2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6B8AAE0-2158-472D-9336-EE4E95CA0A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0D86B91-136D-47E8-809B-6D068AD10E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8CE31E-7448-4A97-9AD1-07EB3AE79A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64268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8C8CF6E-65F8-4F7D-9F39-17665E9A84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FDB2D6-EC92-4A52-8BCB-41D3B941C5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9D1AF6-E53D-4FE2-BE60-7A3423B9A3E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59DF50-F92D-4D13-91A3-C7AB7449A668}" type="datetimeFigureOut">
              <a:rPr lang="en-US" smtClean="0"/>
              <a:t>6/2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08807A-F0C9-403D-9107-7489E87A234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469EE9-DCE0-44E4-ABE4-A56967EABD6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8CE31E-7448-4A97-9AD1-07EB3AE79A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2054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TextBox 36">
            <a:extLst>
              <a:ext uri="{FF2B5EF4-FFF2-40B4-BE49-F238E27FC236}">
                <a16:creationId xmlns:a16="http://schemas.microsoft.com/office/drawing/2014/main" id="{52CAD566-375A-E30E-13D0-936F3287EE12}"/>
              </a:ext>
            </a:extLst>
          </p:cNvPr>
          <p:cNvSpPr txBox="1"/>
          <p:nvPr/>
        </p:nvSpPr>
        <p:spPr>
          <a:xfrm>
            <a:off x="3002466" y="930700"/>
            <a:ext cx="3782889" cy="1787910"/>
          </a:xfrm>
          <a:prstGeom prst="rect">
            <a:avLst/>
          </a:prstGeom>
          <a:ln w="190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 anchor="ctr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400" b="1" dirty="0"/>
              <a:t>Patients</a:t>
            </a:r>
            <a:endParaRPr lang="en-US" sz="1400" b="1" baseline="0" dirty="0"/>
          </a:p>
          <a:p>
            <a:pPr marL="396875" lvl="2" indent="-173038">
              <a:buFont typeface="Arial" panose="020B0604020202020204" pitchFamily="34" charset="0"/>
              <a:buChar char="•"/>
            </a:pPr>
            <a:r>
              <a:rPr lang="en-US" sz="1400" baseline="0" dirty="0"/>
              <a:t>age ≥18 </a:t>
            </a:r>
          </a:p>
          <a:p>
            <a:pPr marL="396875" lvl="2" indent="-173038">
              <a:buFont typeface="Arial" panose="020B0604020202020204" pitchFamily="34" charset="0"/>
              <a:buChar char="•"/>
            </a:pPr>
            <a:r>
              <a:rPr lang="en-US" sz="1400" baseline="0" dirty="0"/>
              <a:t>5/1/</a:t>
            </a:r>
            <a:r>
              <a:rPr lang="en-US" sz="1400" baseline="0" dirty="0">
                <a:solidFill>
                  <a:schemeClr val="dk1"/>
                </a:solidFill>
                <a:effectLst/>
                <a:latin typeface="+mn-lt"/>
                <a:ea typeface="+mn-ea"/>
                <a:cs typeface="+mn-cs"/>
              </a:rPr>
              <a:t>2020-12/31/2021 </a:t>
            </a:r>
          </a:p>
          <a:p>
            <a:pPr marL="396875" lvl="2" indent="-173038">
              <a:buFont typeface="Arial" panose="020B0604020202020204" pitchFamily="34" charset="0"/>
              <a:buChar char="•"/>
            </a:pPr>
            <a:r>
              <a:rPr lang="en-US" sz="1400" baseline="0" dirty="0">
                <a:solidFill>
                  <a:schemeClr val="dk1"/>
                </a:solidFill>
                <a:effectLst/>
                <a:latin typeface="+mn-lt"/>
                <a:ea typeface="+mn-ea"/>
                <a:cs typeface="+mn-cs"/>
              </a:rPr>
              <a:t>≥ 1 </a:t>
            </a:r>
            <a:r>
              <a:rPr lang="en-US" sz="1400" dirty="0"/>
              <a:t>m</a:t>
            </a:r>
            <a:r>
              <a:rPr lang="en-US" sz="1400" baseline="0" dirty="0"/>
              <a:t>ental health in-person or </a:t>
            </a:r>
            <a:r>
              <a:rPr lang="en-US" sz="1400" dirty="0"/>
              <a:t>v</a:t>
            </a:r>
            <a:r>
              <a:rPr lang="en-US" sz="1400" b="0" i="0" dirty="0">
                <a:solidFill>
                  <a:schemeClr val="dk1"/>
                </a:solidFill>
                <a:effectLst/>
                <a:latin typeface="+mn-lt"/>
                <a:ea typeface="+mn-ea"/>
                <a:cs typeface="+mn-cs"/>
              </a:rPr>
              <a:t>irtual vi</a:t>
            </a:r>
            <a:r>
              <a:rPr lang="en-US" sz="1400" baseline="0" dirty="0"/>
              <a:t>sit</a:t>
            </a:r>
          </a:p>
          <a:p>
            <a:pPr marL="396875" lvl="2" indent="-173038">
              <a:buFont typeface="Arial" panose="020B0604020202020204" pitchFamily="34" charset="0"/>
              <a:buChar char="•"/>
            </a:pPr>
            <a:r>
              <a:rPr lang="en-US" sz="1400" dirty="0"/>
              <a:t>Continuous health system enrollment in 12 months prior to mental health visit</a:t>
            </a:r>
            <a:r>
              <a:rPr lang="en-US" sz="1400" baseline="0" dirty="0"/>
              <a:t>  </a:t>
            </a:r>
            <a:r>
              <a:rPr lang="en-US" sz="1400" b="0" i="0" u="none" strike="noStrike" dirty="0">
                <a:solidFill>
                  <a:schemeClr val="dk1"/>
                </a:solidFill>
                <a:effectLst/>
                <a:latin typeface="+mn-lt"/>
                <a:ea typeface="+mn-ea"/>
                <a:cs typeface="+mn-cs"/>
              </a:rPr>
              <a:t> </a:t>
            </a:r>
            <a:r>
              <a:rPr lang="en-US" sz="1400" dirty="0"/>
              <a:t> </a:t>
            </a:r>
          </a:p>
          <a:p>
            <a:pPr algn="ctr"/>
            <a:endParaRPr lang="en-US" sz="1400" baseline="0" dirty="0"/>
          </a:p>
          <a:p>
            <a:pPr algn="ctr"/>
            <a:r>
              <a:rPr lang="en-US" sz="1400" baseline="0" dirty="0"/>
              <a:t>N</a:t>
            </a:r>
            <a:r>
              <a:rPr lang="en-US" sz="1400" baseline="0" dirty="0">
                <a:solidFill>
                  <a:schemeClr val="dk1"/>
                </a:solidFill>
                <a:latin typeface="+mn-lt"/>
                <a:ea typeface="+mn-ea"/>
                <a:cs typeface="+mn-cs"/>
              </a:rPr>
              <a:t>= </a:t>
            </a:r>
            <a:r>
              <a:rPr lang="en-US" sz="1400" baseline="0" dirty="0"/>
              <a:t>335,250</a:t>
            </a:r>
            <a:endParaRPr lang="en-US" sz="1400" baseline="0" dirty="0">
              <a:solidFill>
                <a:schemeClr val="dk1"/>
              </a:solidFill>
              <a:latin typeface="+mn-lt"/>
              <a:ea typeface="+mn-ea"/>
              <a:cs typeface="+mn-cs"/>
            </a:endParaRPr>
          </a:p>
        </p:txBody>
      </p:sp>
      <p:cxnSp>
        <p:nvCxnSpPr>
          <p:cNvPr id="72" name="Straight Arrow Connector 71">
            <a:extLst>
              <a:ext uri="{FF2B5EF4-FFF2-40B4-BE49-F238E27FC236}">
                <a16:creationId xmlns:a16="http://schemas.microsoft.com/office/drawing/2014/main" id="{2E58B87E-06C9-2622-8210-673FCDBE066B}"/>
              </a:ext>
            </a:extLst>
          </p:cNvPr>
          <p:cNvCxnSpPr>
            <a:cxnSpLocks/>
          </p:cNvCxnSpPr>
          <p:nvPr/>
        </p:nvCxnSpPr>
        <p:spPr>
          <a:xfrm flipH="1">
            <a:off x="3572935" y="2770494"/>
            <a:ext cx="1" cy="658506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Arrow Connector 75">
            <a:extLst>
              <a:ext uri="{FF2B5EF4-FFF2-40B4-BE49-F238E27FC236}">
                <a16:creationId xmlns:a16="http://schemas.microsoft.com/office/drawing/2014/main" id="{2956CA56-283E-FEDA-971B-D33028C703C9}"/>
              </a:ext>
            </a:extLst>
          </p:cNvPr>
          <p:cNvCxnSpPr>
            <a:cxnSpLocks/>
          </p:cNvCxnSpPr>
          <p:nvPr/>
        </p:nvCxnSpPr>
        <p:spPr>
          <a:xfrm>
            <a:off x="3668110" y="4680924"/>
            <a:ext cx="1428175" cy="943143"/>
          </a:xfrm>
          <a:prstGeom prst="straightConnector1">
            <a:avLst/>
          </a:prstGeom>
          <a:ln w="38100"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Arrow Connector 77">
            <a:extLst>
              <a:ext uri="{FF2B5EF4-FFF2-40B4-BE49-F238E27FC236}">
                <a16:creationId xmlns:a16="http://schemas.microsoft.com/office/drawing/2014/main" id="{320E7B3F-8A35-732A-BA61-890607A41E6F}"/>
              </a:ext>
            </a:extLst>
          </p:cNvPr>
          <p:cNvCxnSpPr>
            <a:cxnSpLocks/>
          </p:cNvCxnSpPr>
          <p:nvPr/>
        </p:nvCxnSpPr>
        <p:spPr>
          <a:xfrm flipH="1">
            <a:off x="5930508" y="2750855"/>
            <a:ext cx="1" cy="678145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Slide Number Placeholder 4">
            <a:extLst>
              <a:ext uri="{FF2B5EF4-FFF2-40B4-BE49-F238E27FC236}">
                <a16:creationId xmlns:a16="http://schemas.microsoft.com/office/drawing/2014/main" id="{4F9AA94A-4EF1-9F90-A30A-AD691DB5BC82}"/>
              </a:ext>
            </a:extLst>
          </p:cNvPr>
          <p:cNvSpPr txBox="1">
            <a:spLocks/>
          </p:cNvSpPr>
          <p:nvPr/>
        </p:nvSpPr>
        <p:spPr>
          <a:xfrm>
            <a:off x="533400" y="6610350"/>
            <a:ext cx="228600" cy="2286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defPPr>
              <a:defRPr lang="en-US"/>
            </a:defPPr>
            <a:lvl1pPr marL="0" algn="l" defTabSz="914400" rtl="0" eaLnBrk="1" latinLnBrk="0" hangingPunct="1">
              <a:defRPr sz="9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fld id="{06B54077-DDC4-8645-A9B4-3523D661A7EA}" type="slidenum">
              <a:rPr lang="en-US" smtClean="0"/>
              <a:pPr/>
              <a:t>1</a:t>
            </a:fld>
            <a:endParaRPr lang="en-US"/>
          </a:p>
        </p:txBody>
      </p:sp>
      <p:sp>
        <p:nvSpPr>
          <p:cNvPr id="34" name="Title 5">
            <a:extLst>
              <a:ext uri="{FF2B5EF4-FFF2-40B4-BE49-F238E27FC236}">
                <a16:creationId xmlns:a16="http://schemas.microsoft.com/office/drawing/2014/main" id="{78D716D9-4C01-218D-C52B-48E6478005D2}"/>
              </a:ext>
            </a:extLst>
          </p:cNvPr>
          <p:cNvSpPr txBox="1">
            <a:spLocks/>
          </p:cNvSpPr>
          <p:nvPr/>
        </p:nvSpPr>
        <p:spPr>
          <a:xfrm>
            <a:off x="533400" y="983974"/>
            <a:ext cx="3782894" cy="5150240"/>
          </a:xfrm>
          <a:prstGeom prst="rect">
            <a:avLst/>
          </a:prstGeom>
        </p:spPr>
        <p:txBody>
          <a:bodyPr vert="horz" lIns="0" tIns="0" rIns="0" bIns="0" rtlCol="0" anchor="t" anchorCtr="0">
            <a:noAutofit/>
          </a:bodyPr>
          <a:lstStyle>
            <a:lvl1pPr algn="l" defTabSz="914400" rtl="0" eaLnBrk="1" latinLnBrk="0" hangingPunct="1">
              <a:lnSpc>
                <a:spcPct val="85000"/>
              </a:lnSpc>
              <a:spcBef>
                <a:spcPct val="0"/>
              </a:spcBef>
              <a:buNone/>
              <a:defRPr sz="2400" b="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endParaRPr lang="en-US"/>
          </a:p>
        </p:txBody>
      </p:sp>
      <p:sp>
        <p:nvSpPr>
          <p:cNvPr id="57" name="TextBox 51">
            <a:extLst>
              <a:ext uri="{FF2B5EF4-FFF2-40B4-BE49-F238E27FC236}">
                <a16:creationId xmlns:a16="http://schemas.microsoft.com/office/drawing/2014/main" id="{0C72D4AF-5CA0-439C-8922-5511420B5EFB}"/>
              </a:ext>
            </a:extLst>
          </p:cNvPr>
          <p:cNvSpPr txBox="1"/>
          <p:nvPr/>
        </p:nvSpPr>
        <p:spPr>
          <a:xfrm>
            <a:off x="2190685" y="3439137"/>
            <a:ext cx="2500905" cy="1247288"/>
          </a:xfrm>
          <a:prstGeom prst="rect">
            <a:avLst/>
          </a:prstGeom>
          <a:ln w="190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 anchor="ctr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400" b="1" baseline="0" dirty="0"/>
              <a:t>Cases</a:t>
            </a:r>
          </a:p>
          <a:p>
            <a:pPr algn="ctr"/>
            <a:r>
              <a:rPr lang="en-US" sz="1400" baseline="0" dirty="0"/>
              <a:t>Received recommendation to </a:t>
            </a:r>
            <a:r>
              <a:rPr lang="en-US" sz="1400" baseline="0" dirty="0" err="1"/>
              <a:t>DTx</a:t>
            </a:r>
            <a:r>
              <a:rPr lang="en-US" sz="1400" baseline="0" dirty="0"/>
              <a:t> within 30 days of index visit N=5</a:t>
            </a:r>
            <a:r>
              <a:rPr lang="en-US" sz="1400" b="0" i="0" dirty="0">
                <a:solidFill>
                  <a:srgbClr val="000000"/>
                </a:solidFill>
                <a:effectLst/>
              </a:rPr>
              <a:t>3,546</a:t>
            </a:r>
            <a:endParaRPr lang="en-US" sz="1400" baseline="0" dirty="0">
              <a:solidFill>
                <a:schemeClr val="dk1"/>
              </a:solidFill>
              <a:ea typeface="+mn-ea"/>
              <a:cs typeface="+mn-cs"/>
            </a:endParaRPr>
          </a:p>
        </p:txBody>
      </p:sp>
      <p:sp>
        <p:nvSpPr>
          <p:cNvPr id="58" name="TextBox 63">
            <a:extLst>
              <a:ext uri="{FF2B5EF4-FFF2-40B4-BE49-F238E27FC236}">
                <a16:creationId xmlns:a16="http://schemas.microsoft.com/office/drawing/2014/main" id="{9BE5A0F7-C5F1-8F4A-4EF4-5ECAFE911399}"/>
              </a:ext>
            </a:extLst>
          </p:cNvPr>
          <p:cNvSpPr txBox="1"/>
          <p:nvPr/>
        </p:nvSpPr>
        <p:spPr>
          <a:xfrm>
            <a:off x="5096285" y="3441708"/>
            <a:ext cx="2505180" cy="1244717"/>
          </a:xfrm>
          <a:prstGeom prst="rect">
            <a:avLst/>
          </a:prstGeom>
          <a:ln w="190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400" baseline="0" dirty="0"/>
              <a:t>Did not received </a:t>
            </a:r>
            <a:r>
              <a:rPr lang="en-US" sz="1400" baseline="0" dirty="0" err="1"/>
              <a:t>DTx</a:t>
            </a:r>
            <a:r>
              <a:rPr lang="en-US" sz="1400" baseline="0" dirty="0"/>
              <a:t> recommendation within 30 days of index visit </a:t>
            </a:r>
          </a:p>
          <a:p>
            <a:pPr algn="ctr"/>
            <a:r>
              <a:rPr lang="en-US" sz="1400" dirty="0">
                <a:solidFill>
                  <a:schemeClr val="dk1"/>
                </a:solidFill>
                <a:latin typeface="+mn-lt"/>
                <a:ea typeface="+mn-ea"/>
                <a:cs typeface="+mn-cs"/>
              </a:rPr>
              <a:t>N=281,704</a:t>
            </a:r>
            <a:endParaRPr lang="en-US" sz="1400" baseline="0" dirty="0">
              <a:solidFill>
                <a:schemeClr val="dk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61" name="TextBox 63">
            <a:extLst>
              <a:ext uri="{FF2B5EF4-FFF2-40B4-BE49-F238E27FC236}">
                <a16:creationId xmlns:a16="http://schemas.microsoft.com/office/drawing/2014/main" id="{4D9CF05B-2929-0361-0C7F-A6E01B3570D5}"/>
              </a:ext>
            </a:extLst>
          </p:cNvPr>
          <p:cNvSpPr txBox="1"/>
          <p:nvPr/>
        </p:nvSpPr>
        <p:spPr>
          <a:xfrm>
            <a:off x="5096285" y="5295027"/>
            <a:ext cx="2500905" cy="1264545"/>
          </a:xfrm>
          <a:prstGeom prst="rect">
            <a:avLst/>
          </a:prstGeom>
          <a:ln w="190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lIns="91440" tIns="45720" rIns="91440" bIns="45720"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sz="1200" dirty="0"/>
          </a:p>
          <a:p>
            <a:pPr algn="ctr"/>
            <a:r>
              <a:rPr lang="en-US" sz="1400" b="1" dirty="0"/>
              <a:t>Matched Controls</a:t>
            </a:r>
          </a:p>
          <a:p>
            <a:pPr algn="ctr"/>
            <a:r>
              <a:rPr lang="en-US" sz="1400" dirty="0"/>
              <a:t>Matched 1:1 to cases by sex, 5 year age group &amp; medical service area</a:t>
            </a:r>
          </a:p>
          <a:p>
            <a:pPr algn="ctr"/>
            <a:r>
              <a:rPr lang="en-US" sz="1400" dirty="0">
                <a:latin typeface="+mn-lt"/>
                <a:ea typeface="+mn-ea"/>
                <a:cs typeface="+mn-cs"/>
              </a:rPr>
              <a:t>N=53,545</a:t>
            </a:r>
            <a:endParaRPr lang="en-US" sz="1200" dirty="0">
              <a:latin typeface="+mn-lt"/>
              <a:ea typeface="+mn-ea"/>
              <a:cs typeface="+mn-cs"/>
            </a:endParaRPr>
          </a:p>
          <a:p>
            <a:pPr algn="ctr"/>
            <a:endParaRPr lang="en-US" sz="1200" baseline="0" dirty="0">
              <a:solidFill>
                <a:schemeClr val="dk1"/>
              </a:solidFill>
              <a:latin typeface="+mn-lt"/>
              <a:ea typeface="+mn-ea"/>
              <a:cs typeface="+mn-cs"/>
            </a:endParaRP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44541C6F-C955-42D6-8F65-1987E5618D6C}"/>
              </a:ext>
            </a:extLst>
          </p:cNvPr>
          <p:cNvCxnSpPr>
            <a:cxnSpLocks/>
          </p:cNvCxnSpPr>
          <p:nvPr/>
        </p:nvCxnSpPr>
        <p:spPr>
          <a:xfrm flipH="1">
            <a:off x="6387377" y="4660985"/>
            <a:ext cx="1" cy="586943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239535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c4cce11b-c66c-46a3-92bc-30aa31fde102">
      <Terms xmlns="http://schemas.microsoft.com/office/infopath/2007/PartnerControls"/>
    </lcf76f155ced4ddcb4097134ff3c332f>
    <TaxCatchAll xmlns="b75731b3-1c52-48cc-976c-8ed23533ff95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BDD6612D86256429B5770BFA597D8BE" ma:contentTypeVersion="12" ma:contentTypeDescription="Create a new document." ma:contentTypeScope="" ma:versionID="718d2e24af7a5c0fc76dacfbe6e784fa">
  <xsd:schema xmlns:xsd="http://www.w3.org/2001/XMLSchema" xmlns:xs="http://www.w3.org/2001/XMLSchema" xmlns:p="http://schemas.microsoft.com/office/2006/metadata/properties" xmlns:ns2="c4cce11b-c66c-46a3-92bc-30aa31fde102" xmlns:ns3="b75731b3-1c52-48cc-976c-8ed23533ff95" targetNamespace="http://schemas.microsoft.com/office/2006/metadata/properties" ma:root="true" ma:fieldsID="f0195fcc382be78af11dba20be4f9895" ns2:_="" ns3:_="">
    <xsd:import namespace="c4cce11b-c66c-46a3-92bc-30aa31fde102"/>
    <xsd:import namespace="b75731b3-1c52-48cc-976c-8ed23533ff95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4cce11b-c66c-46a3-92bc-30aa31fde10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lcf76f155ced4ddcb4097134ff3c332f" ma:index="13" nillable="true" ma:taxonomy="true" ma:internalName="lcf76f155ced4ddcb4097134ff3c332f" ma:taxonomyFieldName="MediaServiceImageTags" ma:displayName="Image Tags" ma:readOnly="false" ma:fieldId="{5cf76f15-5ced-4ddc-b409-7134ff3c332f}" ma:taxonomyMulti="true" ma:sspId="c9112196-7e5b-431e-8fea-f50fb91bcefa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bjectDetectorVersions" ma:index="18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9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75731b3-1c52-48cc-976c-8ed23533ff95" elementFormDefault="qualified">
    <xsd:import namespace="http://schemas.microsoft.com/office/2006/documentManagement/types"/>
    <xsd:import namespace="http://schemas.microsoft.com/office/infopath/2007/PartnerControls"/>
    <xsd:element name="TaxCatchAll" ma:index="14" nillable="true" ma:displayName="Taxonomy Catch All Column" ma:hidden="true" ma:list="{4d4e74c9-31a8-43bd-bed4-a206146f544a}" ma:internalName="TaxCatchAll" ma:showField="CatchAllData" ma:web="b75731b3-1c52-48cc-976c-8ed23533ff95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92374369-750A-4A8F-92DE-B47B687898CA}">
  <ds:schemaRefs>
    <ds:schemaRef ds:uri="http://www.w3.org/XML/1998/namespace"/>
    <ds:schemaRef ds:uri="http://schemas.microsoft.com/office/2006/documentManagement/types"/>
    <ds:schemaRef ds:uri="c4cce11b-c66c-46a3-92bc-30aa31fde102"/>
    <ds:schemaRef ds:uri="http://purl.org/dc/terms/"/>
    <ds:schemaRef ds:uri="http://schemas.microsoft.com/office/infopath/2007/PartnerControls"/>
    <ds:schemaRef ds:uri="http://purl.org/dc/elements/1.1/"/>
    <ds:schemaRef ds:uri="http://schemas.openxmlformats.org/package/2006/metadata/core-properties"/>
    <ds:schemaRef ds:uri="b75731b3-1c52-48cc-976c-8ed23533ff95"/>
    <ds:schemaRef ds:uri="http://schemas.microsoft.com/office/2006/metadata/properties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1B664ACE-7546-47E9-B877-6E3C6DE078BC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70FF53BB-B27A-4055-B14D-040BC78686F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c4cce11b-c66c-46a3-92bc-30aa31fde102"/>
    <ds:schemaRef ds:uri="b75731b3-1c52-48cc-976c-8ed23533ff95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13</TotalTime>
  <Words>137</Words>
  <Application>Microsoft Office PowerPoint</Application>
  <PresentationFormat>Widescreen</PresentationFormat>
  <Paragraphs>2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Wingdings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eresa Y Lin</dc:creator>
  <cp:lastModifiedBy>Cynthia Campbell</cp:lastModifiedBy>
  <cp:revision>9</cp:revision>
  <dcterms:created xsi:type="dcterms:W3CDTF">2024-05-08T22:42:55Z</dcterms:created>
  <dcterms:modified xsi:type="dcterms:W3CDTF">2024-06-30T00:54:4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BDD6612D86256429B5770BFA597D8BE</vt:lpwstr>
  </property>
  <property fmtid="{D5CDD505-2E9C-101B-9397-08002B2CF9AE}" pid="3" name="MediaServiceImageTags">
    <vt:lpwstr/>
  </property>
</Properties>
</file>